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9361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8537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25947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7941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470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6287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0793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6815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5749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4879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3754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ED9C82-9EBE-4584-B818-745E41CD4AAE}" type="datetimeFigureOut">
              <a:rPr lang="de-DE" smtClean="0"/>
              <a:t>03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FFCB0C-D9E2-422B-885A-041DDCE399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2320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uppieren 35"/>
          <p:cNvGrpSpPr/>
          <p:nvPr/>
        </p:nvGrpSpPr>
        <p:grpSpPr>
          <a:xfrm>
            <a:off x="852447" y="234316"/>
            <a:ext cx="10289030" cy="4388443"/>
            <a:chOff x="980018" y="612003"/>
            <a:chExt cx="10289030" cy="4388443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29436" y="1279269"/>
              <a:ext cx="3845426" cy="3330831"/>
            </a:xfrm>
            <a:prstGeom prst="rect">
              <a:avLst/>
            </a:prstGeom>
          </p:spPr>
        </p:pic>
        <p:grpSp>
          <p:nvGrpSpPr>
            <p:cNvPr id="31" name="Gruppieren 30"/>
            <p:cNvGrpSpPr/>
            <p:nvPr/>
          </p:nvGrpSpPr>
          <p:grpSpPr>
            <a:xfrm>
              <a:off x="980018" y="998233"/>
              <a:ext cx="647934" cy="3622942"/>
              <a:chOff x="1154842" y="998233"/>
              <a:chExt cx="647934" cy="3622942"/>
            </a:xfrm>
          </p:grpSpPr>
          <p:sp>
            <p:nvSpPr>
              <p:cNvPr id="4" name="Textfeld 3"/>
              <p:cNvSpPr txBox="1"/>
              <p:nvPr/>
            </p:nvSpPr>
            <p:spPr>
              <a:xfrm>
                <a:off x="1277786" y="998233"/>
                <a:ext cx="46358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 smtClean="0"/>
                  <a:t>kDa</a:t>
                </a:r>
                <a:endParaRPr lang="de-DE" sz="1400" dirty="0"/>
              </a:p>
            </p:txBody>
          </p:sp>
          <p:sp>
            <p:nvSpPr>
              <p:cNvPr id="5" name="Textfeld 4"/>
              <p:cNvSpPr txBox="1"/>
              <p:nvPr/>
            </p:nvSpPr>
            <p:spPr>
              <a:xfrm>
                <a:off x="1154842" y="1438067"/>
                <a:ext cx="6479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- 180 -</a:t>
                </a:r>
                <a:endParaRPr lang="de-DE" sz="1400" dirty="0"/>
              </a:p>
            </p:txBody>
          </p:sp>
          <p:sp>
            <p:nvSpPr>
              <p:cNvPr id="6" name="Textfeld 5"/>
              <p:cNvSpPr txBox="1"/>
              <p:nvPr/>
            </p:nvSpPr>
            <p:spPr>
              <a:xfrm>
                <a:off x="1154842" y="1745345"/>
                <a:ext cx="6479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- 130 -</a:t>
                </a:r>
                <a:endParaRPr lang="de-DE" sz="1400" dirty="0"/>
              </a:p>
            </p:txBody>
          </p:sp>
          <p:sp>
            <p:nvSpPr>
              <p:cNvPr id="7" name="Textfeld 6"/>
              <p:cNvSpPr txBox="1"/>
              <p:nvPr/>
            </p:nvSpPr>
            <p:spPr>
              <a:xfrm>
                <a:off x="1154842" y="2149278"/>
                <a:ext cx="6479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- 100 -</a:t>
                </a:r>
                <a:endParaRPr lang="de-DE" sz="1400" dirty="0"/>
              </a:p>
            </p:txBody>
          </p:sp>
          <p:sp>
            <p:nvSpPr>
              <p:cNvPr id="8" name="Textfeld 7"/>
              <p:cNvSpPr txBox="1"/>
              <p:nvPr/>
            </p:nvSpPr>
            <p:spPr>
              <a:xfrm>
                <a:off x="1246213" y="2589382"/>
                <a:ext cx="5565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- 70 -</a:t>
                </a:r>
                <a:endParaRPr lang="de-DE" sz="1400" dirty="0"/>
              </a:p>
            </p:txBody>
          </p:sp>
          <p:sp>
            <p:nvSpPr>
              <p:cNvPr id="9" name="Textfeld 8"/>
              <p:cNvSpPr txBox="1"/>
              <p:nvPr/>
            </p:nvSpPr>
            <p:spPr>
              <a:xfrm>
                <a:off x="1246213" y="3015990"/>
                <a:ext cx="5565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- 55 -</a:t>
                </a:r>
                <a:endParaRPr lang="de-DE" sz="1400" dirty="0"/>
              </a:p>
            </p:txBody>
          </p:sp>
          <p:sp>
            <p:nvSpPr>
              <p:cNvPr id="10" name="Textfeld 9"/>
              <p:cNvSpPr txBox="1"/>
              <p:nvPr/>
            </p:nvSpPr>
            <p:spPr>
              <a:xfrm>
                <a:off x="1246213" y="3512038"/>
                <a:ext cx="5565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- 40 -</a:t>
                </a:r>
                <a:endParaRPr lang="de-DE" sz="1400" dirty="0"/>
              </a:p>
            </p:txBody>
          </p:sp>
          <p:sp>
            <p:nvSpPr>
              <p:cNvPr id="11" name="Textfeld 10"/>
              <p:cNvSpPr txBox="1"/>
              <p:nvPr/>
            </p:nvSpPr>
            <p:spPr>
              <a:xfrm>
                <a:off x="1246213" y="4073857"/>
                <a:ext cx="5565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- 35 -</a:t>
                </a:r>
                <a:endParaRPr lang="de-DE" sz="1400" dirty="0"/>
              </a:p>
            </p:txBody>
          </p:sp>
          <p:sp>
            <p:nvSpPr>
              <p:cNvPr id="12" name="Textfeld 11"/>
              <p:cNvSpPr txBox="1"/>
              <p:nvPr/>
            </p:nvSpPr>
            <p:spPr>
              <a:xfrm>
                <a:off x="1246213" y="4313398"/>
                <a:ext cx="5565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- 25 -</a:t>
                </a:r>
                <a:endParaRPr lang="de-DE" sz="1400" dirty="0"/>
              </a:p>
            </p:txBody>
          </p:sp>
        </p:grpSp>
        <p:sp>
          <p:nvSpPr>
            <p:cNvPr id="13" name="Textfeld 12"/>
            <p:cNvSpPr txBox="1"/>
            <p:nvPr/>
          </p:nvSpPr>
          <p:spPr>
            <a:xfrm>
              <a:off x="2965648" y="612003"/>
              <a:ext cx="12329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8 % </a:t>
              </a:r>
              <a:r>
                <a:rPr lang="de-DE" dirty="0" err="1" smtClean="0"/>
                <a:t>gel</a:t>
              </a:r>
              <a:r>
                <a:rPr lang="de-DE" dirty="0" smtClean="0"/>
                <a:t> </a:t>
              </a:r>
              <a:endParaRPr lang="de-DE" dirty="0"/>
            </a:p>
          </p:txBody>
        </p:sp>
        <p:pic>
          <p:nvPicPr>
            <p:cNvPr id="15" name="Grafik 1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407086" y="1279268"/>
              <a:ext cx="3861962" cy="3330831"/>
            </a:xfrm>
            <a:prstGeom prst="rect">
              <a:avLst/>
            </a:prstGeom>
          </p:spPr>
        </p:pic>
        <p:sp>
          <p:nvSpPr>
            <p:cNvPr id="16" name="Textfeld 15"/>
            <p:cNvSpPr txBox="1"/>
            <p:nvPr/>
          </p:nvSpPr>
          <p:spPr>
            <a:xfrm>
              <a:off x="8855563" y="633972"/>
              <a:ext cx="9650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10 % </a:t>
              </a:r>
              <a:r>
                <a:rPr lang="de-DE" dirty="0" err="1" smtClean="0"/>
                <a:t>gel</a:t>
              </a:r>
              <a:endParaRPr lang="de-DE" dirty="0"/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6863986" y="971491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 smtClean="0"/>
                <a:t>kDa</a:t>
              </a:r>
              <a:endParaRPr lang="de-DE" sz="1400" dirty="0"/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6759774" y="1283668"/>
              <a:ext cx="6479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- 180 -</a:t>
              </a:r>
              <a:endParaRPr lang="de-DE" sz="1400" dirty="0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6759774" y="1441819"/>
              <a:ext cx="6479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- 130 -</a:t>
              </a:r>
              <a:endParaRPr lang="de-DE" sz="1400" dirty="0"/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6759774" y="1711742"/>
              <a:ext cx="6479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- 100 -</a:t>
              </a:r>
              <a:endParaRPr lang="de-DE" sz="1400" dirty="0"/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6851145" y="2013319"/>
              <a:ext cx="5565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- 70 -</a:t>
              </a:r>
              <a:endParaRPr lang="de-DE" sz="1400" dirty="0"/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6851145" y="2430707"/>
              <a:ext cx="5565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- 55 -</a:t>
              </a:r>
              <a:endParaRPr lang="de-DE" sz="1400" dirty="0"/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6851145" y="2848095"/>
              <a:ext cx="5565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- 40 -</a:t>
              </a:r>
              <a:endParaRPr lang="de-DE" sz="1400" dirty="0"/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6851145" y="3308540"/>
              <a:ext cx="5565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- 35 -</a:t>
              </a:r>
              <a:endParaRPr lang="de-DE" sz="1400" dirty="0"/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6811070" y="3827499"/>
              <a:ext cx="5966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- 25 - </a:t>
              </a:r>
              <a:endParaRPr lang="de-DE" sz="1400" dirty="0"/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6851145" y="4413699"/>
              <a:ext cx="5565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- 15 -</a:t>
              </a:r>
              <a:endParaRPr lang="de-DE" sz="1400" dirty="0"/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2226365" y="4631114"/>
              <a:ext cx="31967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 smtClean="0"/>
                <a:t>lacZ</a:t>
              </a:r>
              <a:r>
                <a:rPr lang="de-DE" dirty="0" smtClean="0"/>
                <a:t>           M         S        N      RBD</a:t>
              </a:r>
              <a:endParaRPr lang="de-DE" dirty="0"/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7884454" y="4631041"/>
              <a:ext cx="32496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 smtClean="0"/>
                <a:t>lacZ</a:t>
              </a:r>
              <a:r>
                <a:rPr lang="de-DE" dirty="0" smtClean="0"/>
                <a:t>           M          S        N      RBD</a:t>
              </a:r>
              <a:endParaRPr lang="de-DE" dirty="0"/>
            </a:p>
          </p:txBody>
        </p:sp>
      </p:grpSp>
      <p:sp>
        <p:nvSpPr>
          <p:cNvPr id="35" name="Rechteck 34"/>
          <p:cNvSpPr/>
          <p:nvPr/>
        </p:nvSpPr>
        <p:spPr>
          <a:xfrm>
            <a:off x="603685" y="4754060"/>
            <a:ext cx="10846193" cy="197348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49580"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tein expression patterns of adenoviral vectors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d2-lacZ, Ad2-RBD-IRES-M, Ad2-S, Ad2-N, Ad2-RBD) 48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ours after transient transfection of 5 x 10e7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.v.p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n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 x10e6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la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ells. Detection of HA-tagged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tigen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re performed by anti-HA-HRP (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ltenyi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130-091-972) and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isualised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y ECL-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emiluminescence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 </a:t>
            </a:r>
            <a:endParaRPr lang="de-DE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449580"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egative control: Ad-</a:t>
            </a:r>
            <a:r>
              <a:rPr lang="en-US" sz="1200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acZ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he Membrane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tein (M) has a calculated molecular weight of 25,2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d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shows two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nds at 27 and 20 </a:t>
            </a:r>
            <a:r>
              <a:rPr lang="en-US" sz="1200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Da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10% gel). Full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ength spike (S) has a calculated molecular weight of 141,2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d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shows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wo band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t 180 and 90 </a:t>
            </a:r>
            <a:r>
              <a:rPr lang="en-US" sz="1200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Da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The </a:t>
            </a:r>
            <a:r>
              <a:rPr lang="en-US" sz="1200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cleocapsidprotein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) has a calculated weight of 45,6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d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shows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ree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nds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t 53, 47 and 45 </a:t>
            </a:r>
            <a:r>
              <a:rPr lang="en-US" sz="1200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Da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The RBD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as a calculated weight of 34,9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d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shows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wo major bands at 39 and 35 </a:t>
            </a:r>
            <a:r>
              <a:rPr lang="en-US" sz="1200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Da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The levels of antigen expression between S, N and the RBD are comparable, while the expression level of the membrane protein reaches only 20-30% compared to the other three antigens. The reduced expression of M is most likely be attributed to its position under the IRES site (in the double gene vector) while the other three antigens are directly driven from a CMV promoter. </a:t>
            </a:r>
            <a:endParaRPr lang="de-D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0991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2</Words>
  <Application>Microsoft Office PowerPoint</Application>
  <PresentationFormat>Breitbild</PresentationFormat>
  <Paragraphs>2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ichon, Günter</dc:creator>
  <cp:lastModifiedBy>Cichon, Günter</cp:lastModifiedBy>
  <cp:revision>11</cp:revision>
  <dcterms:created xsi:type="dcterms:W3CDTF">2021-11-03T10:37:19Z</dcterms:created>
  <dcterms:modified xsi:type="dcterms:W3CDTF">2021-11-03T14:59:02Z</dcterms:modified>
</cp:coreProperties>
</file>